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75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7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1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3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6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5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7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15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0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6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4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5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57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26A712-4F0B-42C7-B15D-A5E6C34103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73" t="23839" r="14714" b="20374"/>
          <a:stretch/>
        </p:blipFill>
        <p:spPr>
          <a:xfrm>
            <a:off x="1387147" y="1499380"/>
            <a:ext cx="6553394" cy="5229315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1370326" y="1851687"/>
            <a:ext cx="683502" cy="3861049"/>
            <a:chOff x="2821392" y="2084693"/>
            <a:chExt cx="305503" cy="2644055"/>
          </a:xfrm>
        </p:grpSpPr>
        <p:sp>
          <p:nvSpPr>
            <p:cNvPr id="10" name="TextBox 15">
              <a:extLst>
                <a:ext uri="{FF2B5EF4-FFF2-40B4-BE49-F238E27FC236}">
                  <a16:creationId xmlns:a16="http://schemas.microsoft.com/office/drawing/2014/main" id="{5B52F292-C729-44E7-A1E1-54A8D228DF36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712430"/>
              <a:ext cx="201163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98800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3290989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607890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991525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4296838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451798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1363766A-A672-429E-A6AA-155EA5DAAA01}"/>
              </a:ext>
            </a:extLst>
          </p:cNvPr>
          <p:cNvSpPr txBox="1"/>
          <p:nvPr/>
        </p:nvSpPr>
        <p:spPr>
          <a:xfrm>
            <a:off x="1668185" y="5618430"/>
            <a:ext cx="377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254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470B070-3078-45B5-AD48-7D59AC3DE2B0}"/>
              </a:ext>
            </a:extLst>
          </p:cNvPr>
          <p:cNvGrpSpPr/>
          <p:nvPr/>
        </p:nvGrpSpPr>
        <p:grpSpPr>
          <a:xfrm>
            <a:off x="2647585" y="1594295"/>
            <a:ext cx="3517331" cy="411281"/>
            <a:chOff x="3758767" y="2095456"/>
            <a:chExt cx="1757609" cy="411281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89D2837-1B23-4543-AD5E-190044F9EE9F}"/>
                </a:ext>
              </a:extLst>
            </p:cNvPr>
            <p:cNvSpPr txBox="1"/>
            <p:nvPr/>
          </p:nvSpPr>
          <p:spPr>
            <a:xfrm rot="5400000">
              <a:off x="3654621" y="2210773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8107036-848D-4820-A9C4-EB0BFF05971A}"/>
                </a:ext>
              </a:extLst>
            </p:cNvPr>
            <p:cNvSpPr txBox="1"/>
            <p:nvPr/>
          </p:nvSpPr>
          <p:spPr>
            <a:xfrm rot="5400000">
              <a:off x="3923247" y="2210773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>
              <a:defPPr>
                <a:defRPr lang="en-US"/>
              </a:defPPr>
              <a:lvl1pPr>
                <a:defRPr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sz="1400" b="1" dirty="0"/>
                <a:t>2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BB766BD-520D-4CA4-932B-6A9EA094CD16}"/>
                </a:ext>
              </a:extLst>
            </p:cNvPr>
            <p:cNvSpPr txBox="1"/>
            <p:nvPr/>
          </p:nvSpPr>
          <p:spPr>
            <a:xfrm rot="5400000">
              <a:off x="4186944" y="2210773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0AF7A6B-D0F9-4FA0-8B49-F864D29D2F51}"/>
                </a:ext>
              </a:extLst>
            </p:cNvPr>
            <p:cNvSpPr txBox="1"/>
            <p:nvPr/>
          </p:nvSpPr>
          <p:spPr>
            <a:xfrm rot="5400000">
              <a:off x="4429717" y="2210773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E9EC5F5-5659-453A-B1D9-5AA88163D068}"/>
                </a:ext>
              </a:extLst>
            </p:cNvPr>
            <p:cNvSpPr txBox="1"/>
            <p:nvPr/>
          </p:nvSpPr>
          <p:spPr>
            <a:xfrm rot="5400000">
              <a:off x="4694348" y="2210773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7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340F5C4-2437-4638-8949-5F55C8477D8B}"/>
                </a:ext>
              </a:extLst>
            </p:cNvPr>
            <p:cNvSpPr txBox="1"/>
            <p:nvPr/>
          </p:nvSpPr>
          <p:spPr>
            <a:xfrm rot="5400000">
              <a:off x="4967870" y="2199602"/>
              <a:ext cx="400110" cy="19181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DEE0049-73F0-4F33-9BAA-86BD2013BB62}"/>
                </a:ext>
              </a:extLst>
            </p:cNvPr>
            <p:cNvSpPr txBox="1"/>
            <p:nvPr/>
          </p:nvSpPr>
          <p:spPr>
            <a:xfrm rot="5400000">
              <a:off x="5220413" y="2199604"/>
              <a:ext cx="400110" cy="1918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</a:p>
          </p:txBody>
        </p: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89AFF317-81D4-43FF-8C97-9B6C423B6D89}"/>
              </a:ext>
            </a:extLst>
          </p:cNvPr>
          <p:cNvSpPr txBox="1"/>
          <p:nvPr/>
        </p:nvSpPr>
        <p:spPr>
          <a:xfrm>
            <a:off x="3400710" y="748837"/>
            <a:ext cx="209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k Fractions</a:t>
            </a:r>
          </a:p>
        </p:txBody>
      </p:sp>
      <p:sp>
        <p:nvSpPr>
          <p:cNvPr id="66" name="Left Brace 65">
            <a:extLst>
              <a:ext uri="{FF2B5EF4-FFF2-40B4-BE49-F238E27FC236}">
                <a16:creationId xmlns:a16="http://schemas.microsoft.com/office/drawing/2014/main" id="{C19A7455-4542-483B-9529-42CBD43F09F2}"/>
              </a:ext>
            </a:extLst>
          </p:cNvPr>
          <p:cNvSpPr/>
          <p:nvPr/>
        </p:nvSpPr>
        <p:spPr>
          <a:xfrm rot="5400000">
            <a:off x="4233592" y="-550969"/>
            <a:ext cx="204493" cy="3574685"/>
          </a:xfrm>
          <a:prstGeom prst="leftBrace">
            <a:avLst>
              <a:gd name="adj1" fmla="val 38729"/>
              <a:gd name="adj2" fmla="val 49486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 b="1"/>
          </a:p>
        </p:txBody>
      </p:sp>
      <p:sp>
        <p:nvSpPr>
          <p:cNvPr id="67" name="Left Brace 66">
            <a:extLst>
              <a:ext uri="{FF2B5EF4-FFF2-40B4-BE49-F238E27FC236}">
                <a16:creationId xmlns:a16="http://schemas.microsoft.com/office/drawing/2014/main" id="{5850022F-5EBA-4399-9FBC-9E9AD1715528}"/>
              </a:ext>
            </a:extLst>
          </p:cNvPr>
          <p:cNvSpPr/>
          <p:nvPr/>
        </p:nvSpPr>
        <p:spPr>
          <a:xfrm rot="5400000">
            <a:off x="3690216" y="952069"/>
            <a:ext cx="219880" cy="1455444"/>
          </a:xfrm>
          <a:prstGeom prst="leftBrace">
            <a:avLst>
              <a:gd name="adj1" fmla="val 38729"/>
              <a:gd name="adj2" fmla="val 49486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 b="1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0689DC3-6C35-47B9-B759-F2D13FEA56E7}"/>
              </a:ext>
            </a:extLst>
          </p:cNvPr>
          <p:cNvSpPr txBox="1"/>
          <p:nvPr/>
        </p:nvSpPr>
        <p:spPr>
          <a:xfrm>
            <a:off x="2810624" y="1201053"/>
            <a:ext cx="209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oled Fractions</a:t>
            </a:r>
          </a:p>
        </p:txBody>
      </p:sp>
      <p:sp>
        <p:nvSpPr>
          <p:cNvPr id="52" name="Title 4">
            <a:extLst>
              <a:ext uri="{FF2B5EF4-FFF2-40B4-BE49-F238E27FC236}">
                <a16:creationId xmlns:a16="http://schemas.microsoft.com/office/drawing/2014/main" id="{0DFE109C-3BD0-4521-B977-5D28B1B31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68024" y="17474"/>
            <a:ext cx="7886700" cy="859628"/>
          </a:xfrm>
        </p:spPr>
        <p:txBody>
          <a:bodyPr>
            <a:norm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Uncropped </a:t>
            </a:r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masie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illiant Blue Stained Gel Used for Making Figure 6B Panel 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AB3B344-BAE8-4940-AF91-434F04DEFFDE}"/>
              </a:ext>
            </a:extLst>
          </p:cNvPr>
          <p:cNvSpPr txBox="1"/>
          <p:nvPr/>
        </p:nvSpPr>
        <p:spPr>
          <a:xfrm>
            <a:off x="4191351" y="6418059"/>
            <a:ext cx="1514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oomassie</a:t>
            </a:r>
          </a:p>
        </p:txBody>
      </p:sp>
    </p:spTree>
    <p:extLst>
      <p:ext uri="{BB962C8B-B14F-4D97-AF65-F5344CB8AC3E}">
        <p14:creationId xmlns:p14="http://schemas.microsoft.com/office/powerpoint/2010/main" val="79629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6B791461-1E8C-49DC-8134-D8D6EE9314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4851"/>
          <a:stretch/>
        </p:blipFill>
        <p:spPr>
          <a:xfrm>
            <a:off x="2041441" y="2396423"/>
            <a:ext cx="4468878" cy="3314700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1805813" y="2472761"/>
            <a:ext cx="69075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5E880A01-F230-42C7-9999-7D4B3808FB61}"/>
              </a:ext>
            </a:extLst>
          </p:cNvPr>
          <p:cNvSpPr txBox="1"/>
          <p:nvPr/>
        </p:nvSpPr>
        <p:spPr>
          <a:xfrm>
            <a:off x="3830474" y="5717489"/>
            <a:ext cx="11786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5FDAFD6-CEE2-487B-A0E8-F7C2785C44F7}"/>
              </a:ext>
            </a:extLst>
          </p:cNvPr>
          <p:cNvSpPr txBox="1"/>
          <p:nvPr/>
        </p:nvSpPr>
        <p:spPr>
          <a:xfrm>
            <a:off x="4531200" y="1076713"/>
            <a:ext cx="400110" cy="12559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 Marker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8131963-33D8-4E51-84D2-A40D99C2F5A1}"/>
              </a:ext>
            </a:extLst>
          </p:cNvPr>
          <p:cNvSpPr txBox="1"/>
          <p:nvPr/>
        </p:nvSpPr>
        <p:spPr>
          <a:xfrm>
            <a:off x="4829302" y="1287637"/>
            <a:ext cx="543739" cy="104498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V Pr55</a:t>
            </a:r>
            <a:r>
              <a: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</a:p>
          <a:p>
            <a:endParaRPr lang="en-US" sz="14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D5558A2-B968-4642-86B4-CFE60710EC29}"/>
              </a:ext>
            </a:extLst>
          </p:cNvPr>
          <p:cNvSpPr/>
          <p:nvPr/>
        </p:nvSpPr>
        <p:spPr>
          <a:xfrm>
            <a:off x="3009246" y="6136041"/>
            <a:ext cx="26831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33" name="Title 4">
            <a:extLst>
              <a:ext uri="{FF2B5EF4-FFF2-40B4-BE49-F238E27FC236}">
                <a16:creationId xmlns:a16="http://schemas.microsoft.com/office/drawing/2014/main" id="{C81D5318-31BB-4799-9E86-151121D74686}"/>
              </a:ext>
            </a:extLst>
          </p:cNvPr>
          <p:cNvSpPr txBox="1">
            <a:spLocks/>
          </p:cNvSpPr>
          <p:nvPr/>
        </p:nvSpPr>
        <p:spPr>
          <a:xfrm>
            <a:off x="546765" y="330955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(continued): Uncropped Western Blot Used for Making Figure 6B Panel b</a:t>
            </a:r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EE77AF57-F374-4070-84FF-86F84AB3C56A}"/>
              </a:ext>
            </a:extLst>
          </p:cNvPr>
          <p:cNvSpPr/>
          <p:nvPr/>
        </p:nvSpPr>
        <p:spPr>
          <a:xfrm>
            <a:off x="4669811" y="2321409"/>
            <a:ext cx="138225" cy="307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15D2DA65-0079-427B-BC5F-106DCA4B650B}"/>
              </a:ext>
            </a:extLst>
          </p:cNvPr>
          <p:cNvSpPr/>
          <p:nvPr/>
        </p:nvSpPr>
        <p:spPr>
          <a:xfrm>
            <a:off x="4978546" y="2321409"/>
            <a:ext cx="138225" cy="307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714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2008732" y="2602487"/>
            <a:ext cx="69075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7F7D9902-CF48-47E5-93DB-09C037D4DC1C}"/>
              </a:ext>
            </a:extLst>
          </p:cNvPr>
          <p:cNvSpPr txBox="1"/>
          <p:nvPr/>
        </p:nvSpPr>
        <p:spPr>
          <a:xfrm>
            <a:off x="3888610" y="5707815"/>
            <a:ext cx="11786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27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8561266-6440-4123-9FA5-71D20710D31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5759"/>
          <a:stretch/>
        </p:blipFill>
        <p:spPr>
          <a:xfrm>
            <a:off x="2663497" y="2375935"/>
            <a:ext cx="3371543" cy="3314700"/>
          </a:xfrm>
          <a:prstGeom prst="rect">
            <a:avLst/>
          </a:prstGeom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FD5558A2-B968-4642-86B4-CFE60710EC29}"/>
              </a:ext>
            </a:extLst>
          </p:cNvPr>
          <p:cNvSpPr/>
          <p:nvPr/>
        </p:nvSpPr>
        <p:spPr>
          <a:xfrm>
            <a:off x="3265712" y="6032772"/>
            <a:ext cx="26125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33" name="Title 4">
            <a:extLst>
              <a:ext uri="{FF2B5EF4-FFF2-40B4-BE49-F238E27FC236}">
                <a16:creationId xmlns:a16="http://schemas.microsoft.com/office/drawing/2014/main" id="{C81D5318-31BB-4799-9E86-151121D74686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(continued): Uncropped Western Blot Used for Making Figure 6B Panel 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1BB1DF7-386D-4D4A-A8BF-42D46FD3B37B}"/>
              </a:ext>
            </a:extLst>
          </p:cNvPr>
          <p:cNvSpPr txBox="1"/>
          <p:nvPr/>
        </p:nvSpPr>
        <p:spPr>
          <a:xfrm>
            <a:off x="4669429" y="1023548"/>
            <a:ext cx="400110" cy="12559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 Marke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0CD9ED4-FE7C-483B-8588-216C2A77D5F7}"/>
              </a:ext>
            </a:extLst>
          </p:cNvPr>
          <p:cNvSpPr txBox="1"/>
          <p:nvPr/>
        </p:nvSpPr>
        <p:spPr>
          <a:xfrm>
            <a:off x="4967531" y="1234472"/>
            <a:ext cx="543739" cy="104498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V Pr55</a:t>
            </a:r>
            <a:r>
              <a: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</a:p>
          <a:p>
            <a:endParaRPr lang="en-US" sz="14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Arrow: Down 21">
            <a:extLst>
              <a:ext uri="{FF2B5EF4-FFF2-40B4-BE49-F238E27FC236}">
                <a16:creationId xmlns:a16="http://schemas.microsoft.com/office/drawing/2014/main" id="{4BC2099D-C9DE-4014-ADEA-80E8F14B3B52}"/>
              </a:ext>
            </a:extLst>
          </p:cNvPr>
          <p:cNvSpPr/>
          <p:nvPr/>
        </p:nvSpPr>
        <p:spPr>
          <a:xfrm>
            <a:off x="4808040" y="2268244"/>
            <a:ext cx="138225" cy="307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47611468-416B-43E4-885F-3C355F9D204C}"/>
              </a:ext>
            </a:extLst>
          </p:cNvPr>
          <p:cNvSpPr/>
          <p:nvPr/>
        </p:nvSpPr>
        <p:spPr>
          <a:xfrm>
            <a:off x="5116775" y="2268244"/>
            <a:ext cx="138225" cy="307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785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4</TotalTime>
  <Words>122</Words>
  <Application>Microsoft Office PowerPoint</Application>
  <PresentationFormat>On-screen Show (4:3)</PresentationFormat>
  <Paragraphs>5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 4: Uncropped Coomasie Brilliant Blue Stained Gel Used for Making Figure 6B Panel 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:</dc:title>
  <dc:creator>Vineeta Pillai</dc:creator>
  <cp:lastModifiedBy>Vineeta Pillai</cp:lastModifiedBy>
  <cp:revision>53</cp:revision>
  <dcterms:created xsi:type="dcterms:W3CDTF">2022-12-10T15:40:15Z</dcterms:created>
  <dcterms:modified xsi:type="dcterms:W3CDTF">2022-12-14T08:34:51Z</dcterms:modified>
</cp:coreProperties>
</file>